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7" r:id="rId2"/>
    <p:sldId id="258" r:id="rId3"/>
    <p:sldId id="259" r:id="rId4"/>
    <p:sldId id="260" r:id="rId5"/>
    <p:sldId id="261" r:id="rId6"/>
    <p:sldId id="262" r:id="rId7"/>
    <p:sldId id="265" r:id="rId8"/>
    <p:sldId id="263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3" d="100"/>
          <a:sy n="153" d="100"/>
        </p:scale>
        <p:origin x="5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7F8AE9-D4A2-4724-B84F-D72623FFFFAA}" type="datetimeFigureOut">
              <a:rPr lang="zh-CN" altLang="en-US" smtClean="0"/>
              <a:t>2025/11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0820C4-9B00-4B2D-AE93-EA134523FC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2230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0820C4-9B00-4B2D-AE93-EA134523FC6F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07295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AA14D9-DBAC-667B-7867-BD8410A012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4E929D5-2CA0-2190-6C43-1E1627830A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4E345BA-667E-122E-AFDA-56B4D72C1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25DFC-146A-48D2-A7FE-4BEE18A7009E}" type="datetimeFigureOut">
              <a:rPr lang="zh-CN" altLang="en-US" smtClean="0"/>
              <a:t>2025/1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99ECE7-94FC-22F3-7B0B-34E7EEFCE2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DEE24AC-0B82-605D-CDBF-94D3292BC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826EE-1B00-4356-BB88-9BD516B0AD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3671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F9C970-3229-916E-684D-22BEC65255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716D8AE-12BF-C18F-86EF-839EA615F6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FD1AC38-7DF6-2575-4CE2-EC033D880F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25DFC-146A-48D2-A7FE-4BEE18A7009E}" type="datetimeFigureOut">
              <a:rPr lang="zh-CN" altLang="en-US" smtClean="0"/>
              <a:t>2025/1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6AAEA2-341A-872F-9201-9367117CDD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C7A4A1-C9F9-ED04-8539-6791FCA74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826EE-1B00-4356-BB88-9BD516B0AD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5816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44ECFA7-D403-5FE6-E9E1-3066A14C06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C240183-737E-B0DF-A04D-630146EF9C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55C244B-2F84-1653-13E8-DA0B8F66A4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25DFC-146A-48D2-A7FE-4BEE18A7009E}" type="datetimeFigureOut">
              <a:rPr lang="zh-CN" altLang="en-US" smtClean="0"/>
              <a:t>2025/1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52E6D6A-3013-68B2-6B93-9CEAAD31A2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85AD08-B4EF-8C91-8C65-48B115252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826EE-1B00-4356-BB88-9BD516B0AD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6931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6EB608-9AAC-EA6E-8EB8-F6F05AED3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94DB348-E470-7DCB-9C88-A255C667D3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D59292F-EBBA-3A34-FF71-CAEFF299D7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25DFC-146A-48D2-A7FE-4BEE18A7009E}" type="datetimeFigureOut">
              <a:rPr lang="zh-CN" altLang="en-US" smtClean="0"/>
              <a:t>2025/1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010160-E4AD-F809-2D97-7F1850901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802EE3-72DE-59A8-3C07-1075EBB2F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826EE-1B00-4356-BB88-9BD516B0AD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36939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74685E2-F04C-A1FC-92B7-8A5FBDBCB2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A834BA1-97C4-F79F-045E-A4BB9D0B64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2113922-0C04-3C68-8B1B-F3EF2B905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25DFC-146A-48D2-A7FE-4BEE18A7009E}" type="datetimeFigureOut">
              <a:rPr lang="zh-CN" altLang="en-US" smtClean="0"/>
              <a:t>2025/1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EC7DF4-F1F4-E6CD-AC99-779849DF7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67B623-EE42-0D53-93E4-4ECE9C2D62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826EE-1B00-4356-BB88-9BD516B0AD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6153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E5B7FC-B1D0-B251-C388-6545CD18A5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EC2AD65-AD40-82E3-65E3-9C288B3F05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2284EE6-8054-758A-6287-5757EA3D26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C69C577-7419-FCF3-F02F-5E2BD52DF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25DFC-146A-48D2-A7FE-4BEE18A7009E}" type="datetimeFigureOut">
              <a:rPr lang="zh-CN" altLang="en-US" smtClean="0"/>
              <a:t>2025/1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BC80BF-F678-6DFC-6C30-7CA97FBCF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DF994DD-F17E-26B3-A54E-1343F9F462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826EE-1B00-4356-BB88-9BD516B0AD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7846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9E39A8-ABDD-B8E7-10AE-4B530991C6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F05A06C-7ABE-DDD1-4786-A021E6AA85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1524C43-A864-C572-E88C-022D128751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0331C30-B1BB-2DFA-E222-5FDD39FBB1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920ED97-F49A-46EE-F18F-FBF12A224E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5FB46BC-8F90-E855-9EE7-2C5A702A1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25DFC-146A-48D2-A7FE-4BEE18A7009E}" type="datetimeFigureOut">
              <a:rPr lang="zh-CN" altLang="en-US" smtClean="0"/>
              <a:t>2025/11/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A30D4F1-CBBC-3F31-DFE2-7A4BBDF036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DCB9EE-7C0D-D4B3-49B0-E0983AFB64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826EE-1B00-4356-BB88-9BD516B0AD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3448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E69A12-D974-D770-3B77-4A0E2C4A64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61D35B5-98B1-6140-232D-A464B90B83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25DFC-146A-48D2-A7FE-4BEE18A7009E}" type="datetimeFigureOut">
              <a:rPr lang="zh-CN" altLang="en-US" smtClean="0"/>
              <a:t>2025/11/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4000B3F-3716-22CB-64E0-E1E1B75FA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386CC67-259A-7F37-C4E7-CB108E9F4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826EE-1B00-4356-BB88-9BD516B0AD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31823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D9977DB-01C9-A1A2-9962-19B9BE296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25DFC-146A-48D2-A7FE-4BEE18A7009E}" type="datetimeFigureOut">
              <a:rPr lang="zh-CN" altLang="en-US" smtClean="0"/>
              <a:t>2025/11/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8D7AE22-6CB2-2D01-C048-AE5E80B4D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D4D40EB-00EE-5957-D569-3DABC3C39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826EE-1B00-4356-BB88-9BD516B0AD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6040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70DCD5-4EE4-7964-167D-243DBFCE0D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C9172FE-5705-95F1-1F09-A55CFBC550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0EECF29-CE51-48DF-9DD6-5E5A88ED28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F2E35FD-B637-7D23-C154-AB1688A7C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25DFC-146A-48D2-A7FE-4BEE18A7009E}" type="datetimeFigureOut">
              <a:rPr lang="zh-CN" altLang="en-US" smtClean="0"/>
              <a:t>2025/1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D7AB52B-4744-4CBF-D65D-67590DA05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EDA50E3-91DB-54F4-C131-267E314396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826EE-1B00-4356-BB88-9BD516B0AD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2301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31B9F7-FC3F-B9C8-6B47-9EE91DEC1F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4BE9CEB-73AD-C487-3B21-32CBEC9399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30A020C-915D-3EFE-D2E2-7597F233C3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F835F34-08A1-5A91-8E14-6B08EEB63C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25DFC-146A-48D2-A7FE-4BEE18A7009E}" type="datetimeFigureOut">
              <a:rPr lang="zh-CN" altLang="en-US" smtClean="0"/>
              <a:t>2025/1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DF9E6C8-AA13-E5DB-DA42-2C751379E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BA6F69A-3FE2-27F9-4E0A-3FAA7F8CE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826EE-1B00-4356-BB88-9BD516B0AD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8420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BB12F8F-40F1-0B0F-F5FF-C54D4DD1B8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F030CEF-59F8-CF6C-A920-5D834D27F3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71CFA3-4517-8F6B-5D8C-3B7FF277BA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E525DFC-146A-48D2-A7FE-4BEE18A7009E}" type="datetimeFigureOut">
              <a:rPr lang="zh-CN" altLang="en-US" smtClean="0"/>
              <a:t>2025/1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C0FA80-10A6-14E0-284B-4A64D2ADA5A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3C66AE-A0B3-BB8D-5B34-DA90CCCB25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58826EE-1B00-4356-BB88-9BD516B0AD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4144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13" Type="http://schemas.openxmlformats.org/officeDocument/2006/relationships/image" Target="../media/image37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12" Type="http://schemas.openxmlformats.org/officeDocument/2006/relationships/image" Target="../media/image36.png"/><Relationship Id="rId17" Type="http://schemas.openxmlformats.org/officeDocument/2006/relationships/image" Target="../media/image41.png"/><Relationship Id="rId2" Type="http://schemas.openxmlformats.org/officeDocument/2006/relationships/image" Target="../media/image26.png"/><Relationship Id="rId16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png"/><Relationship Id="rId11" Type="http://schemas.openxmlformats.org/officeDocument/2006/relationships/image" Target="../media/image35.png"/><Relationship Id="rId5" Type="http://schemas.openxmlformats.org/officeDocument/2006/relationships/image" Target="../media/image29.png"/><Relationship Id="rId15" Type="http://schemas.openxmlformats.org/officeDocument/2006/relationships/image" Target="../media/image39.png"/><Relationship Id="rId10" Type="http://schemas.openxmlformats.org/officeDocument/2006/relationships/image" Target="../media/image34.png"/><Relationship Id="rId4" Type="http://schemas.openxmlformats.org/officeDocument/2006/relationships/image" Target="../media/image28.png"/><Relationship Id="rId9" Type="http://schemas.openxmlformats.org/officeDocument/2006/relationships/image" Target="../media/image33.png"/><Relationship Id="rId14" Type="http://schemas.openxmlformats.org/officeDocument/2006/relationships/image" Target="../media/image3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png"/><Relationship Id="rId13" Type="http://schemas.openxmlformats.org/officeDocument/2006/relationships/image" Target="../media/image53.png"/><Relationship Id="rId3" Type="http://schemas.openxmlformats.org/officeDocument/2006/relationships/image" Target="../media/image43.png"/><Relationship Id="rId7" Type="http://schemas.openxmlformats.org/officeDocument/2006/relationships/image" Target="../media/image47.png"/><Relationship Id="rId12" Type="http://schemas.openxmlformats.org/officeDocument/2006/relationships/image" Target="../media/image52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png"/><Relationship Id="rId11" Type="http://schemas.openxmlformats.org/officeDocument/2006/relationships/image" Target="../media/image51.png"/><Relationship Id="rId5" Type="http://schemas.openxmlformats.org/officeDocument/2006/relationships/image" Target="../media/image45.png"/><Relationship Id="rId10" Type="http://schemas.openxmlformats.org/officeDocument/2006/relationships/image" Target="../media/image50.png"/><Relationship Id="rId4" Type="http://schemas.openxmlformats.org/officeDocument/2006/relationships/image" Target="../media/image44.png"/><Relationship Id="rId9" Type="http://schemas.openxmlformats.org/officeDocument/2006/relationships/image" Target="../media/image49.png"/><Relationship Id="rId14" Type="http://schemas.openxmlformats.org/officeDocument/2006/relationships/image" Target="../media/image5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3" Type="http://schemas.openxmlformats.org/officeDocument/2006/relationships/image" Target="../media/image56.png"/><Relationship Id="rId7" Type="http://schemas.openxmlformats.org/officeDocument/2006/relationships/image" Target="../media/image60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png"/><Relationship Id="rId5" Type="http://schemas.openxmlformats.org/officeDocument/2006/relationships/image" Target="../media/image58.png"/><Relationship Id="rId4" Type="http://schemas.openxmlformats.org/officeDocument/2006/relationships/image" Target="../media/image57.png"/><Relationship Id="rId9" Type="http://schemas.openxmlformats.org/officeDocument/2006/relationships/image" Target="../media/image6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8.png"/><Relationship Id="rId13" Type="http://schemas.openxmlformats.org/officeDocument/2006/relationships/image" Target="../media/image73.png"/><Relationship Id="rId3" Type="http://schemas.openxmlformats.org/officeDocument/2006/relationships/image" Target="../media/image63.png"/><Relationship Id="rId7" Type="http://schemas.openxmlformats.org/officeDocument/2006/relationships/image" Target="../media/image67.png"/><Relationship Id="rId12" Type="http://schemas.openxmlformats.org/officeDocument/2006/relationships/image" Target="../media/image72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6.png"/><Relationship Id="rId11" Type="http://schemas.openxmlformats.org/officeDocument/2006/relationships/image" Target="../media/image71.png"/><Relationship Id="rId5" Type="http://schemas.openxmlformats.org/officeDocument/2006/relationships/image" Target="../media/image65.png"/><Relationship Id="rId15" Type="http://schemas.openxmlformats.org/officeDocument/2006/relationships/image" Target="../media/image75.png"/><Relationship Id="rId10" Type="http://schemas.openxmlformats.org/officeDocument/2006/relationships/image" Target="../media/image70.png"/><Relationship Id="rId4" Type="http://schemas.openxmlformats.org/officeDocument/2006/relationships/image" Target="../media/image64.png"/><Relationship Id="rId9" Type="http://schemas.openxmlformats.org/officeDocument/2006/relationships/image" Target="../media/image69.png"/><Relationship Id="rId14" Type="http://schemas.openxmlformats.org/officeDocument/2006/relationships/image" Target="../media/image7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8.png"/><Relationship Id="rId7" Type="http://schemas.openxmlformats.org/officeDocument/2006/relationships/image" Target="../media/image82.png"/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1.png"/><Relationship Id="rId5" Type="http://schemas.openxmlformats.org/officeDocument/2006/relationships/image" Target="../media/image80.png"/><Relationship Id="rId4" Type="http://schemas.openxmlformats.org/officeDocument/2006/relationships/image" Target="../media/image7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E06D1AB-2DEF-B90E-5958-F7DAB8FF3B69}"/>
              </a:ext>
            </a:extLst>
          </p:cNvPr>
          <p:cNvSpPr txBox="1"/>
          <p:nvPr/>
        </p:nvSpPr>
        <p:spPr>
          <a:xfrm>
            <a:off x="157110" y="164468"/>
            <a:ext cx="18088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ure1A</a:t>
            </a:r>
            <a:endParaRPr lang="zh-CN" altLang="en-US" sz="2400" b="1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39DEBD42-BCD0-51C2-4528-87B8772975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5666" y="1375230"/>
            <a:ext cx="2737382" cy="1597988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E27DA724-3C82-8EAD-80F7-329275736A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4192" y="3439744"/>
            <a:ext cx="3120330" cy="100393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BED767D4-2DCC-5487-7D51-3F1E0415FE8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3687" y="4754267"/>
            <a:ext cx="3429263" cy="1510135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F6EFBE0-4DE6-741A-5B05-D904CB56815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91351" y="1525948"/>
            <a:ext cx="3236975" cy="877311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F931A94A-FE9B-D171-D5F0-C3DCDFA89DD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58343" y="3090672"/>
            <a:ext cx="3368754" cy="1003933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1595115D-3E63-4AA2-3EE6-1F172318C86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91351" y="4754267"/>
            <a:ext cx="3429264" cy="1118767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EE2F9297-2CCA-4131-E23C-87F7DAE89CA3}"/>
              </a:ext>
            </a:extLst>
          </p:cNvPr>
          <p:cNvSpPr txBox="1"/>
          <p:nvPr/>
        </p:nvSpPr>
        <p:spPr>
          <a:xfrm>
            <a:off x="1819656" y="685800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GS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744B7AB-C761-5D74-C106-D3C02611FF0B}"/>
              </a:ext>
            </a:extLst>
          </p:cNvPr>
          <p:cNvSpPr txBox="1"/>
          <p:nvPr/>
        </p:nvSpPr>
        <p:spPr>
          <a:xfrm>
            <a:off x="7708392" y="870466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GC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7709FCB-207E-8CE3-67DA-93F940E78305}"/>
              </a:ext>
            </a:extLst>
          </p:cNvPr>
          <p:cNvSpPr txBox="1"/>
          <p:nvPr/>
        </p:nvSpPr>
        <p:spPr>
          <a:xfrm>
            <a:off x="4114800" y="1964603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TDB1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CF519DE-DD3E-1694-E40D-67F162A79D60}"/>
              </a:ext>
            </a:extLst>
          </p:cNvPr>
          <p:cNvSpPr txBox="1"/>
          <p:nvPr/>
        </p:nvSpPr>
        <p:spPr>
          <a:xfrm>
            <a:off x="4242950" y="3725273"/>
            <a:ext cx="1151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3K9me3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D73F072-2FCB-57CC-4A60-0BF69690DDF2}"/>
              </a:ext>
            </a:extLst>
          </p:cNvPr>
          <p:cNvSpPr txBox="1"/>
          <p:nvPr/>
        </p:nvSpPr>
        <p:spPr>
          <a:xfrm>
            <a:off x="4588647" y="5509334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F4DA48F-9E81-479A-BD54-53D6C11FB3A5}"/>
              </a:ext>
            </a:extLst>
          </p:cNvPr>
          <p:cNvSpPr txBox="1"/>
          <p:nvPr/>
        </p:nvSpPr>
        <p:spPr>
          <a:xfrm>
            <a:off x="10019177" y="1779937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TDB1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D8933AE-0488-4C58-5300-096FE82CCB47}"/>
              </a:ext>
            </a:extLst>
          </p:cNvPr>
          <p:cNvSpPr txBox="1"/>
          <p:nvPr/>
        </p:nvSpPr>
        <p:spPr>
          <a:xfrm>
            <a:off x="10147327" y="3540607"/>
            <a:ext cx="1151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3K9me3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BE1E2E3-E1BB-0D06-D47A-ABBA5B200B33}"/>
              </a:ext>
            </a:extLst>
          </p:cNvPr>
          <p:cNvSpPr txBox="1"/>
          <p:nvPr/>
        </p:nvSpPr>
        <p:spPr>
          <a:xfrm>
            <a:off x="10365335" y="5301277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D14A9B25-C3C0-0044-6E51-E30FAA651258}"/>
              </a:ext>
            </a:extLst>
          </p:cNvPr>
          <p:cNvCxnSpPr/>
          <p:nvPr/>
        </p:nvCxnSpPr>
        <p:spPr>
          <a:xfrm>
            <a:off x="5759450" y="164468"/>
            <a:ext cx="0" cy="6318882"/>
          </a:xfrm>
          <a:prstGeom prst="line">
            <a:avLst/>
          </a:prstGeom>
          <a:ln w="22225"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186143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E87B235C-5B91-8115-3CEA-1BCD7157F9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9735" y="3889003"/>
            <a:ext cx="2606526" cy="66231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DC8419A-2642-FF80-5863-6EC01146DF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735" y="4653764"/>
            <a:ext cx="2606526" cy="760237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6707C6D-A6A1-B147-0D1D-D81D71FF99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8549" y="5618896"/>
            <a:ext cx="2548899" cy="106410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D804234E-8102-9C1F-199F-5AA778414BB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9735" y="2727647"/>
            <a:ext cx="2704762" cy="97142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A08CFD2C-0BF0-229E-485C-75236478038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8549" y="1826536"/>
            <a:ext cx="2606526" cy="741071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1E781C25-D875-791B-8E6F-546E717E444F}"/>
              </a:ext>
            </a:extLst>
          </p:cNvPr>
          <p:cNvSpPr txBox="1"/>
          <p:nvPr/>
        </p:nvSpPr>
        <p:spPr>
          <a:xfrm>
            <a:off x="3903129" y="2163002"/>
            <a:ext cx="848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</a:t>
            </a:r>
            <a:r>
              <a:rPr lang="en-US" altLang="zh-CN" dirty="0" err="1"/>
              <a:t>myc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9530A04-98FA-9997-F581-5F5E4D72E161}"/>
              </a:ext>
            </a:extLst>
          </p:cNvPr>
          <p:cNvSpPr txBox="1"/>
          <p:nvPr/>
        </p:nvSpPr>
        <p:spPr>
          <a:xfrm>
            <a:off x="3702566" y="2975450"/>
            <a:ext cx="1010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yclinD1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552A7DB-A50B-EDE8-5C38-0F4C4C419F1E}"/>
              </a:ext>
            </a:extLst>
          </p:cNvPr>
          <p:cNvSpPr txBox="1"/>
          <p:nvPr/>
        </p:nvSpPr>
        <p:spPr>
          <a:xfrm>
            <a:off x="3702566" y="4128156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K2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5CE069D-AC79-CA79-7050-D1C415E7BD03}"/>
              </a:ext>
            </a:extLst>
          </p:cNvPr>
          <p:cNvSpPr txBox="1"/>
          <p:nvPr/>
        </p:nvSpPr>
        <p:spPr>
          <a:xfrm>
            <a:off x="3593499" y="4998242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K6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832507A-8232-4F7E-9368-384DEDB67CD8}"/>
              </a:ext>
            </a:extLst>
          </p:cNvPr>
          <p:cNvSpPr txBox="1"/>
          <p:nvPr/>
        </p:nvSpPr>
        <p:spPr>
          <a:xfrm>
            <a:off x="3603980" y="6150948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B02146DC-959C-A505-2E0F-E8E7E7939302}"/>
              </a:ext>
            </a:extLst>
          </p:cNvPr>
          <p:cNvSpPr txBox="1"/>
          <p:nvPr/>
        </p:nvSpPr>
        <p:spPr>
          <a:xfrm>
            <a:off x="3762509" y="1018369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SETDB1</a:t>
            </a:r>
            <a:endParaRPr lang="zh-CN" altLang="en-US" dirty="0">
              <a:solidFill>
                <a:srgbClr val="FF0000"/>
              </a:solidFill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E03CBE29-34CB-5CEF-6C83-231D3BF1516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737568" y="5790310"/>
            <a:ext cx="2256986" cy="892689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0733B95B-44B9-3489-0C1A-0332136EBD0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779857" y="4783646"/>
            <a:ext cx="2130551" cy="775140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9CEE934C-7A2E-C2E9-57E4-C2CDC957013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779857" y="3743534"/>
            <a:ext cx="2256986" cy="781264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FC8E9CD7-FD89-2218-7E59-0658B7B0111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779857" y="2702188"/>
            <a:ext cx="2214698" cy="877522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58A61039-B4F1-7F58-36C3-C782E288E75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737568" y="900746"/>
            <a:ext cx="2728572" cy="528572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4CA7932B-1997-BAFC-AA4A-7C03817D333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539833" y="1660842"/>
            <a:ext cx="2737033" cy="877522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A8ACCDA7-DC25-68B6-12C7-7D2B953148F1}"/>
              </a:ext>
            </a:extLst>
          </p:cNvPr>
          <p:cNvSpPr txBox="1"/>
          <p:nvPr/>
        </p:nvSpPr>
        <p:spPr>
          <a:xfrm>
            <a:off x="9573186" y="2053452"/>
            <a:ext cx="848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</a:t>
            </a:r>
            <a:r>
              <a:rPr lang="en-US" altLang="zh-CN" dirty="0" err="1"/>
              <a:t>myc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B6CBA2A-D96A-A7D6-B57D-706720368592}"/>
              </a:ext>
            </a:extLst>
          </p:cNvPr>
          <p:cNvSpPr txBox="1"/>
          <p:nvPr/>
        </p:nvSpPr>
        <p:spPr>
          <a:xfrm>
            <a:off x="9372623" y="2865900"/>
            <a:ext cx="1010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yclinD1</a:t>
            </a:r>
            <a:endParaRPr lang="zh-CN" altLang="en-US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C6A7672C-6004-576F-F8E3-C90C617794C8}"/>
              </a:ext>
            </a:extLst>
          </p:cNvPr>
          <p:cNvSpPr txBox="1"/>
          <p:nvPr/>
        </p:nvSpPr>
        <p:spPr>
          <a:xfrm>
            <a:off x="9372623" y="4018606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K2</a:t>
            </a:r>
            <a:endParaRPr lang="zh-CN" altLang="en-US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7DDB4E5-0CBE-35A5-A459-64A689826CA2}"/>
              </a:ext>
            </a:extLst>
          </p:cNvPr>
          <p:cNvSpPr txBox="1"/>
          <p:nvPr/>
        </p:nvSpPr>
        <p:spPr>
          <a:xfrm>
            <a:off x="9263556" y="4888692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K6</a:t>
            </a:r>
            <a:endParaRPr lang="zh-CN" altLang="en-US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565348CC-0231-6F4B-EC08-AFDAF676D56D}"/>
              </a:ext>
            </a:extLst>
          </p:cNvPr>
          <p:cNvSpPr txBox="1"/>
          <p:nvPr/>
        </p:nvSpPr>
        <p:spPr>
          <a:xfrm>
            <a:off x="9274037" y="6041398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B</a:t>
            </a:r>
            <a:endParaRPr lang="zh-CN" altLang="en-US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4518233E-B581-1680-E41B-DE69C52D0A91}"/>
              </a:ext>
            </a:extLst>
          </p:cNvPr>
          <p:cNvSpPr txBox="1"/>
          <p:nvPr/>
        </p:nvSpPr>
        <p:spPr>
          <a:xfrm>
            <a:off x="9573186" y="900746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TDB1</a:t>
            </a:r>
            <a:endParaRPr lang="zh-CN" altLang="en-US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87272AAC-FC50-4212-FC70-5537707665BC}"/>
              </a:ext>
            </a:extLst>
          </p:cNvPr>
          <p:cNvSpPr txBox="1"/>
          <p:nvPr/>
        </p:nvSpPr>
        <p:spPr>
          <a:xfrm>
            <a:off x="175398" y="175001"/>
            <a:ext cx="19368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ure2C 2D</a:t>
            </a:r>
            <a:endParaRPr lang="zh-CN" altLang="en-US" sz="2400" b="1" dirty="0"/>
          </a:p>
        </p:txBody>
      </p:sp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2F661D7F-65F3-5F65-AC37-E1F6315BB5BE}"/>
              </a:ext>
            </a:extLst>
          </p:cNvPr>
          <p:cNvCxnSpPr/>
          <p:nvPr/>
        </p:nvCxnSpPr>
        <p:spPr>
          <a:xfrm>
            <a:off x="5759450" y="164468"/>
            <a:ext cx="0" cy="6318882"/>
          </a:xfrm>
          <a:prstGeom prst="line">
            <a:avLst/>
          </a:prstGeom>
          <a:ln w="22225"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9" name="图片 8">
            <a:extLst>
              <a:ext uri="{FF2B5EF4-FFF2-40B4-BE49-F238E27FC236}">
                <a16:creationId xmlns:a16="http://schemas.microsoft.com/office/drawing/2014/main" id="{35F2AF23-D356-0142-EBB8-F93EC042096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27119" y="530808"/>
            <a:ext cx="1843625" cy="12290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9946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D30232C-BA9D-00E9-FB2B-71E01923B0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0391" y="5507804"/>
            <a:ext cx="3243897" cy="74719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9410CCE2-61BD-8345-01A4-3EDD78A258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7071" y="4633492"/>
            <a:ext cx="3497217" cy="56172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0DE0FEF-1263-224E-D9C1-B3727C68970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0603" y="3638879"/>
            <a:ext cx="3410151" cy="68203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2134E76-DA9C-1DA7-8B81-7C749CF44CB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6000" y="5380354"/>
            <a:ext cx="3863410" cy="754919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361594BD-A19F-A1B7-A1E4-B7575425AAD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68950" y="4110497"/>
            <a:ext cx="4057528" cy="78832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F48D837F-C2D8-7D0F-B0D1-37C8C4634C4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23073" y="2545568"/>
            <a:ext cx="3836349" cy="1165114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93913559-BCC6-D529-EF5D-F586A563FCDC}"/>
              </a:ext>
            </a:extLst>
          </p:cNvPr>
          <p:cNvSpPr txBox="1"/>
          <p:nvPr/>
        </p:nvSpPr>
        <p:spPr>
          <a:xfrm>
            <a:off x="10358571" y="4136243"/>
            <a:ext cx="848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</a:t>
            </a:r>
            <a:r>
              <a:rPr lang="en-US" altLang="zh-CN" dirty="0" err="1"/>
              <a:t>myc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FE90C44-7488-92F0-7C93-692685B56E11}"/>
              </a:ext>
            </a:extLst>
          </p:cNvPr>
          <p:cNvSpPr txBox="1"/>
          <p:nvPr/>
        </p:nvSpPr>
        <p:spPr>
          <a:xfrm>
            <a:off x="10059422" y="5511145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4752D60-7E86-BA4D-B4F9-65721EEC818F}"/>
              </a:ext>
            </a:extLst>
          </p:cNvPr>
          <p:cNvSpPr txBox="1"/>
          <p:nvPr/>
        </p:nvSpPr>
        <p:spPr>
          <a:xfrm>
            <a:off x="10259185" y="2761341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TDB1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4764894-6D12-14E0-46D3-E4D07C6678EB}"/>
              </a:ext>
            </a:extLst>
          </p:cNvPr>
          <p:cNvSpPr txBox="1"/>
          <p:nvPr/>
        </p:nvSpPr>
        <p:spPr>
          <a:xfrm>
            <a:off x="175398" y="175001"/>
            <a:ext cx="19368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ure2E 2F</a:t>
            </a:r>
            <a:endParaRPr lang="zh-CN" altLang="en-US" sz="24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DC24E80-665F-91AD-943F-050325B51E67}"/>
              </a:ext>
            </a:extLst>
          </p:cNvPr>
          <p:cNvSpPr txBox="1"/>
          <p:nvPr/>
        </p:nvSpPr>
        <p:spPr>
          <a:xfrm>
            <a:off x="4274196" y="3682083"/>
            <a:ext cx="848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</a:t>
            </a:r>
            <a:r>
              <a:rPr lang="en-US" altLang="zh-CN" dirty="0" err="1"/>
              <a:t>myc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6767357-9B86-88E7-4B68-3C04911589D1}"/>
              </a:ext>
            </a:extLst>
          </p:cNvPr>
          <p:cNvSpPr txBox="1"/>
          <p:nvPr/>
        </p:nvSpPr>
        <p:spPr>
          <a:xfrm>
            <a:off x="4231717" y="5593342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C9CC60A-715E-9F92-872F-133283886916}"/>
              </a:ext>
            </a:extLst>
          </p:cNvPr>
          <p:cNvSpPr txBox="1"/>
          <p:nvPr/>
        </p:nvSpPr>
        <p:spPr>
          <a:xfrm>
            <a:off x="4431480" y="2843538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TDB1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F98685B-630F-7CC7-3D93-1D0575C19C0F}"/>
              </a:ext>
            </a:extLst>
          </p:cNvPr>
          <p:cNvSpPr txBox="1"/>
          <p:nvPr/>
        </p:nvSpPr>
        <p:spPr>
          <a:xfrm>
            <a:off x="4330925" y="4714151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C3B</a:t>
            </a:r>
            <a:endParaRPr lang="zh-CN" altLang="en-US" dirty="0"/>
          </a:p>
        </p:txBody>
      </p:sp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98DB61B5-E817-0204-2BAC-F43AE525A434}"/>
              </a:ext>
            </a:extLst>
          </p:cNvPr>
          <p:cNvCxnSpPr/>
          <p:nvPr/>
        </p:nvCxnSpPr>
        <p:spPr>
          <a:xfrm>
            <a:off x="5759450" y="164468"/>
            <a:ext cx="0" cy="6318882"/>
          </a:xfrm>
          <a:prstGeom prst="line">
            <a:avLst/>
          </a:prstGeom>
          <a:ln w="22225"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0" name="图片 9">
            <a:extLst>
              <a:ext uri="{FF2B5EF4-FFF2-40B4-BE49-F238E27FC236}">
                <a16:creationId xmlns:a16="http://schemas.microsoft.com/office/drawing/2014/main" id="{25F79338-38FF-5316-8AC9-28310BE6EF4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97071" y="2224508"/>
            <a:ext cx="3487405" cy="10066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10298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904034B-31AD-8574-91FA-8AE140AE7194}"/>
              </a:ext>
            </a:extLst>
          </p:cNvPr>
          <p:cNvSpPr txBox="1"/>
          <p:nvPr/>
        </p:nvSpPr>
        <p:spPr>
          <a:xfrm>
            <a:off x="157110" y="164468"/>
            <a:ext cx="24306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ure3A 3C</a:t>
            </a:r>
            <a:endParaRPr lang="zh-CN" altLang="en-US" sz="2400" b="1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1326C3DE-B5FE-52CE-B843-54F2912933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69944" y="140826"/>
            <a:ext cx="2430642" cy="65734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53A3910-FC34-3909-C8D3-5D23CA597A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84170" y="2659887"/>
            <a:ext cx="2516416" cy="85141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6D199D09-2888-269D-1A2E-3B3C23B425A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69945" y="945202"/>
            <a:ext cx="2353432" cy="76327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5C65758E-2D55-416A-8792-525CCE6C3DE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69944" y="1855511"/>
            <a:ext cx="2394605" cy="657343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060273B0-EEF3-74EC-E7D2-35A8A01BFF7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69944" y="3570196"/>
            <a:ext cx="2290699" cy="645267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A3FE08D9-267C-7D84-5C34-4B94151661E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36815" y="4374572"/>
            <a:ext cx="2386562" cy="466509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52E53D5E-A404-62B2-2436-C2A8475EC04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36816" y="5000191"/>
            <a:ext cx="2386562" cy="520704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F0BA5718-EF07-3983-49DE-021A3E270C59}"/>
              </a:ext>
            </a:extLst>
          </p:cNvPr>
          <p:cNvSpPr txBox="1"/>
          <p:nvPr/>
        </p:nvSpPr>
        <p:spPr>
          <a:xfrm>
            <a:off x="8837727" y="3708163"/>
            <a:ext cx="848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</a:t>
            </a:r>
            <a:r>
              <a:rPr lang="en-US" altLang="zh-CN" dirty="0" err="1"/>
              <a:t>myc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601E52A-74CA-E3DB-A288-D7A092E37A50}"/>
              </a:ext>
            </a:extLst>
          </p:cNvPr>
          <p:cNvSpPr txBox="1"/>
          <p:nvPr/>
        </p:nvSpPr>
        <p:spPr>
          <a:xfrm>
            <a:off x="8800586" y="4374572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K2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15AD240-F272-B21A-33C8-6142498103F2}"/>
              </a:ext>
            </a:extLst>
          </p:cNvPr>
          <p:cNvSpPr txBox="1"/>
          <p:nvPr/>
        </p:nvSpPr>
        <p:spPr>
          <a:xfrm>
            <a:off x="8868049" y="5045161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K6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26A6DBF-A83D-CAC8-EAFC-090CA096FDC7}"/>
              </a:ext>
            </a:extLst>
          </p:cNvPr>
          <p:cNvSpPr txBox="1"/>
          <p:nvPr/>
        </p:nvSpPr>
        <p:spPr>
          <a:xfrm>
            <a:off x="8854373" y="6012827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ACT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DFF3C4A-A166-2220-0549-20DBBF572B82}"/>
              </a:ext>
            </a:extLst>
          </p:cNvPr>
          <p:cNvSpPr txBox="1"/>
          <p:nvPr/>
        </p:nvSpPr>
        <p:spPr>
          <a:xfrm>
            <a:off x="9179994" y="186440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TDB1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B93D507-9A97-9FE9-525C-61E2D126F61A}"/>
              </a:ext>
            </a:extLst>
          </p:cNvPr>
          <p:cNvSpPr txBox="1"/>
          <p:nvPr/>
        </p:nvSpPr>
        <p:spPr>
          <a:xfrm>
            <a:off x="9001233" y="1142174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F4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D306087-9AA1-8D4E-DF79-08A3113A3131}"/>
              </a:ext>
            </a:extLst>
          </p:cNvPr>
          <p:cNvSpPr txBox="1"/>
          <p:nvPr/>
        </p:nvSpPr>
        <p:spPr>
          <a:xfrm>
            <a:off x="8969038" y="1965175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F6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DDC4CBB-BCF1-8547-DA7C-39BAEAB56D61}"/>
              </a:ext>
            </a:extLst>
          </p:cNvPr>
          <p:cNvSpPr txBox="1"/>
          <p:nvPr/>
        </p:nvSpPr>
        <p:spPr>
          <a:xfrm>
            <a:off x="8919345" y="2828441"/>
            <a:ext cx="788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HOP</a:t>
            </a:r>
            <a:endParaRPr lang="zh-CN" altLang="en-US" dirty="0"/>
          </a:p>
        </p:txBody>
      </p:sp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4261CF57-2A13-A708-138F-42B1A1348BD3}"/>
              </a:ext>
            </a:extLst>
          </p:cNvPr>
          <p:cNvCxnSpPr/>
          <p:nvPr/>
        </p:nvCxnSpPr>
        <p:spPr>
          <a:xfrm>
            <a:off x="5759450" y="164468"/>
            <a:ext cx="0" cy="6318882"/>
          </a:xfrm>
          <a:prstGeom prst="line">
            <a:avLst/>
          </a:prstGeom>
          <a:ln w="22225"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5" name="图片 4">
            <a:extLst>
              <a:ext uri="{FF2B5EF4-FFF2-40B4-BE49-F238E27FC236}">
                <a16:creationId xmlns:a16="http://schemas.microsoft.com/office/drawing/2014/main" id="{A2A5F7AB-8AA9-02FF-FF1D-27FA3BA357D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72712" y="555772"/>
            <a:ext cx="1830589" cy="59184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6A066ED6-2ECD-1B63-4F51-3338FAA107D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75870" y="1233332"/>
            <a:ext cx="1976882" cy="669099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5515644C-FD54-FE02-92C1-44F65DAB534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84110" y="1988147"/>
            <a:ext cx="1873391" cy="629583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58E14C30-FF7B-E468-F0F8-6F9DE87FF6E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00330" y="2735084"/>
            <a:ext cx="1831157" cy="554896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E6FAEB93-2673-A27D-A4DF-4DA222E2410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000331" y="3408144"/>
            <a:ext cx="1873392" cy="629990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C71FC0C6-69D6-06C3-58E0-892CC556DE03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000944" y="5879698"/>
            <a:ext cx="1747376" cy="715592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ADABF01D-EDAF-CF88-69AB-204B5BA7AC2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000944" y="4156298"/>
            <a:ext cx="1747376" cy="679535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93505D5B-CF46-031B-6A04-794CCB3EFFC7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03259" y="5059163"/>
            <a:ext cx="1915056" cy="679536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364E3C05-145C-086C-DDD1-2C0F86297298}"/>
              </a:ext>
            </a:extLst>
          </p:cNvPr>
          <p:cNvSpPr txBox="1"/>
          <p:nvPr/>
        </p:nvSpPr>
        <p:spPr>
          <a:xfrm>
            <a:off x="3089128" y="613503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TDB1</a:t>
            </a:r>
            <a:endParaRPr lang="zh-CN" altLang="en-US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EF8E1570-54C3-4595-DD90-EEE7C26D2C22}"/>
              </a:ext>
            </a:extLst>
          </p:cNvPr>
          <p:cNvSpPr txBox="1"/>
          <p:nvPr/>
        </p:nvSpPr>
        <p:spPr>
          <a:xfrm>
            <a:off x="2782104" y="5245159"/>
            <a:ext cx="788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HOP</a:t>
            </a:r>
            <a:endParaRPr lang="zh-CN" altLang="en-US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FFA90EA9-4B81-C24F-B4C3-34290B870CE0}"/>
              </a:ext>
            </a:extLst>
          </p:cNvPr>
          <p:cNvSpPr txBox="1"/>
          <p:nvPr/>
        </p:nvSpPr>
        <p:spPr>
          <a:xfrm>
            <a:off x="2960761" y="4291805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IP</a:t>
            </a:r>
            <a:endParaRPr lang="zh-CN" altLang="en-US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70842235-E662-7B99-6CFE-17191A1BA1B2}"/>
              </a:ext>
            </a:extLst>
          </p:cNvPr>
          <p:cNvSpPr txBox="1"/>
          <p:nvPr/>
        </p:nvSpPr>
        <p:spPr>
          <a:xfrm>
            <a:off x="3161990" y="2041741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ERK</a:t>
            </a:r>
            <a:endParaRPr lang="zh-CN" altLang="en-US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54FE0020-DF2B-E002-AA7A-E46CEF5EDDB9}"/>
              </a:ext>
            </a:extLst>
          </p:cNvPr>
          <p:cNvSpPr txBox="1"/>
          <p:nvPr/>
        </p:nvSpPr>
        <p:spPr>
          <a:xfrm>
            <a:off x="3080443" y="2808573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F6</a:t>
            </a:r>
            <a:endParaRPr lang="zh-CN" altLang="en-US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B3419DF-2410-E428-A84C-E47177D257EB}"/>
              </a:ext>
            </a:extLst>
          </p:cNvPr>
          <p:cNvSpPr txBox="1"/>
          <p:nvPr/>
        </p:nvSpPr>
        <p:spPr>
          <a:xfrm>
            <a:off x="3081358" y="1310743"/>
            <a:ext cx="936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ERK</a:t>
            </a:r>
            <a:endParaRPr lang="zh-CN" altLang="en-US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15D360A2-4402-FB33-3CB0-EAEB2AEE946D}"/>
              </a:ext>
            </a:extLst>
          </p:cNvPr>
          <p:cNvSpPr txBox="1"/>
          <p:nvPr/>
        </p:nvSpPr>
        <p:spPr>
          <a:xfrm>
            <a:off x="2853981" y="6071878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BD6F2AE9-4A11-0883-6871-1925675C5E3E}"/>
              </a:ext>
            </a:extLst>
          </p:cNvPr>
          <p:cNvSpPr txBox="1"/>
          <p:nvPr/>
        </p:nvSpPr>
        <p:spPr>
          <a:xfrm>
            <a:off x="3027139" y="3538473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RE1α</a:t>
            </a:r>
            <a:endParaRPr lang="zh-CN" altLang="en-US" dirty="0"/>
          </a:p>
        </p:txBody>
      </p:sp>
      <p:pic>
        <p:nvPicPr>
          <p:cNvPr id="49" name="图片 48">
            <a:extLst>
              <a:ext uri="{FF2B5EF4-FFF2-40B4-BE49-F238E27FC236}">
                <a16:creationId xmlns:a16="http://schemas.microsoft.com/office/drawing/2014/main" id="{676656DD-05C5-B773-AF37-7A65EE79AFFF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432550" y="5837758"/>
            <a:ext cx="2128847" cy="6881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52695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D92DAAB-DBF7-CB76-6B9D-754E94421B5F}"/>
              </a:ext>
            </a:extLst>
          </p:cNvPr>
          <p:cNvSpPr txBox="1"/>
          <p:nvPr/>
        </p:nvSpPr>
        <p:spPr>
          <a:xfrm>
            <a:off x="157110" y="164468"/>
            <a:ext cx="24306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ure4A</a:t>
            </a:r>
            <a:endParaRPr lang="zh-CN" altLang="en-US" sz="2400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73F18FC-3A87-CECD-9097-724AD29142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1723" y="822768"/>
            <a:ext cx="1692057" cy="69346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F4BB2D7-CA59-64A5-FFBA-A6D577F4FB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1723" y="1661716"/>
            <a:ext cx="1692057" cy="55911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FE2AEDEB-969C-0C2F-4615-6569AEA5E8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41723" y="2366312"/>
            <a:ext cx="1692057" cy="109486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87CC704-7F62-1A92-EB86-AA2B3EE5860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41723" y="3606655"/>
            <a:ext cx="1692057" cy="666568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2144EB6B-1449-8AE3-2D23-E74E09D0E01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41724" y="4418706"/>
            <a:ext cx="1736066" cy="960097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6FD9AE3A-7A1E-9B95-5826-7CEF3B5CCEC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41722" y="5579678"/>
            <a:ext cx="1736067" cy="51976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12ACA433-CBEF-6D1B-4382-47587314E5C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961344" y="1380091"/>
            <a:ext cx="2566686" cy="744187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69B8EF28-8E74-2F78-77EF-78964761AC9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105736" y="2237209"/>
            <a:ext cx="2028593" cy="764623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63BFE09D-1E2A-F1C7-A0E9-2763844A923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163712" y="3893772"/>
            <a:ext cx="1912635" cy="981819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DF1DE379-82EE-9F5E-B381-89A827713AB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163711" y="4913154"/>
            <a:ext cx="1912635" cy="666524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F96517EE-13D9-9E27-6CA9-F4C5B483CED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096240" y="3114763"/>
            <a:ext cx="2188910" cy="741654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40002A36-EDDC-6578-7DBB-406CA52F91C1}"/>
              </a:ext>
            </a:extLst>
          </p:cNvPr>
          <p:cNvSpPr txBox="1"/>
          <p:nvPr/>
        </p:nvSpPr>
        <p:spPr>
          <a:xfrm>
            <a:off x="9134329" y="5120709"/>
            <a:ext cx="848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</a:t>
            </a:r>
            <a:r>
              <a:rPr lang="en-US" altLang="zh-CN" dirty="0" err="1"/>
              <a:t>myc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2519E488-FE59-4188-3B6C-DEBB197EFE8D}"/>
              </a:ext>
            </a:extLst>
          </p:cNvPr>
          <p:cNvSpPr txBox="1"/>
          <p:nvPr/>
        </p:nvSpPr>
        <p:spPr>
          <a:xfrm>
            <a:off x="9229060" y="5919713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ACT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2AF44762-F323-BE4F-B65D-8BEE4DD1AF4A}"/>
              </a:ext>
            </a:extLst>
          </p:cNvPr>
          <p:cNvSpPr txBox="1"/>
          <p:nvPr/>
        </p:nvSpPr>
        <p:spPr>
          <a:xfrm>
            <a:off x="3687979" y="971256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TDB1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C3A77899-1BD0-DF10-30A4-608050A53289}"/>
              </a:ext>
            </a:extLst>
          </p:cNvPr>
          <p:cNvSpPr txBox="1"/>
          <p:nvPr/>
        </p:nvSpPr>
        <p:spPr>
          <a:xfrm>
            <a:off x="9216081" y="2428111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F4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750DD34B-3A20-7889-C9B5-D76B4F41512F}"/>
              </a:ext>
            </a:extLst>
          </p:cNvPr>
          <p:cNvSpPr txBox="1"/>
          <p:nvPr/>
        </p:nvSpPr>
        <p:spPr>
          <a:xfrm>
            <a:off x="3512482" y="5654892"/>
            <a:ext cx="788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HOP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1325BE9-E1E8-C4D9-BEEE-6B1DA89DABAA}"/>
              </a:ext>
            </a:extLst>
          </p:cNvPr>
          <p:cNvSpPr txBox="1"/>
          <p:nvPr/>
        </p:nvSpPr>
        <p:spPr>
          <a:xfrm>
            <a:off x="9360124" y="3300924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IF2α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F01C723-FDCF-94BC-459A-92F1E19C6B71}"/>
              </a:ext>
            </a:extLst>
          </p:cNvPr>
          <p:cNvSpPr txBox="1"/>
          <p:nvPr/>
        </p:nvSpPr>
        <p:spPr>
          <a:xfrm>
            <a:off x="9217274" y="4321705"/>
            <a:ext cx="9749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eIF2α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D67758C1-859D-5B1F-7439-B73FB2714E5F}"/>
              </a:ext>
            </a:extLst>
          </p:cNvPr>
          <p:cNvSpPr txBox="1"/>
          <p:nvPr/>
        </p:nvSpPr>
        <p:spPr>
          <a:xfrm>
            <a:off x="9285150" y="1426633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IP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5FCB4E4-9718-0644-CBF4-BB59E9B892FE}"/>
              </a:ext>
            </a:extLst>
          </p:cNvPr>
          <p:cNvSpPr txBox="1"/>
          <p:nvPr/>
        </p:nvSpPr>
        <p:spPr>
          <a:xfrm>
            <a:off x="9229060" y="639991"/>
            <a:ext cx="8098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XBP-1</a:t>
            </a:r>
            <a:endParaRPr lang="zh-CN" altLang="en-US" dirty="0"/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AED2E287-82FB-1DA0-CB51-3F1C26FE555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116709" y="482207"/>
            <a:ext cx="2188911" cy="770399"/>
          </a:xfrm>
          <a:prstGeom prst="rect">
            <a:avLst/>
          </a:prstGeom>
        </p:spPr>
      </p:pic>
      <p:sp>
        <p:nvSpPr>
          <p:cNvPr id="38" name="文本框 37">
            <a:extLst>
              <a:ext uri="{FF2B5EF4-FFF2-40B4-BE49-F238E27FC236}">
                <a16:creationId xmlns:a16="http://schemas.microsoft.com/office/drawing/2014/main" id="{486AD326-D36B-AF77-6116-7A689EF358FB}"/>
              </a:ext>
            </a:extLst>
          </p:cNvPr>
          <p:cNvSpPr txBox="1"/>
          <p:nvPr/>
        </p:nvSpPr>
        <p:spPr>
          <a:xfrm>
            <a:off x="3579311" y="1698792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ERK</a:t>
            </a:r>
            <a:endParaRPr lang="zh-CN" altLang="en-US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FDE71D2F-F271-2E40-6A1A-3E2AF2BF610B}"/>
              </a:ext>
            </a:extLst>
          </p:cNvPr>
          <p:cNvSpPr txBox="1"/>
          <p:nvPr/>
        </p:nvSpPr>
        <p:spPr>
          <a:xfrm>
            <a:off x="3456178" y="3755273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F6</a:t>
            </a:r>
            <a:endParaRPr lang="zh-CN" altLang="en-US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CDB1D45E-F3AC-3CB3-C4C7-FA405D6EB234}"/>
              </a:ext>
            </a:extLst>
          </p:cNvPr>
          <p:cNvSpPr txBox="1"/>
          <p:nvPr/>
        </p:nvSpPr>
        <p:spPr>
          <a:xfrm>
            <a:off x="3562976" y="2789228"/>
            <a:ext cx="936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ERK</a:t>
            </a:r>
            <a:endParaRPr lang="zh-CN" altLang="en-US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5BAFA3F7-F055-CA0B-B3C0-8062D5A197DD}"/>
              </a:ext>
            </a:extLst>
          </p:cNvPr>
          <p:cNvSpPr txBox="1"/>
          <p:nvPr/>
        </p:nvSpPr>
        <p:spPr>
          <a:xfrm>
            <a:off x="3535773" y="4688847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RE1α</a:t>
            </a:r>
            <a:endParaRPr lang="zh-CN" altLang="en-US" dirty="0"/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F59AE565-CEC5-E2F4-3A81-1E698680A02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163711" y="5617241"/>
            <a:ext cx="1790272" cy="9499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88676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C0B90A3-8821-82FA-E5EB-B62768FEDF00}"/>
              </a:ext>
            </a:extLst>
          </p:cNvPr>
          <p:cNvSpPr txBox="1"/>
          <p:nvPr/>
        </p:nvSpPr>
        <p:spPr>
          <a:xfrm>
            <a:off x="157110" y="164468"/>
            <a:ext cx="20717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ure 4C</a:t>
            </a:r>
            <a:endParaRPr lang="zh-CN" altLang="en-US" sz="2400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D747C9F-C515-8B10-A93A-3F07CCA5CC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8650" y="164468"/>
            <a:ext cx="2092000" cy="67817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6247CBE-B578-7F56-00CE-E7679D435F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61015" y="964715"/>
            <a:ext cx="2190435" cy="348478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8F91467-E160-BA51-C983-49AC86587A2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61015" y="1435264"/>
            <a:ext cx="2247585" cy="60817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1D882A6D-FEF1-FEC4-2C56-6FC631A8723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54651" y="2190450"/>
            <a:ext cx="2574600" cy="682424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CD7E48D-9AAF-E41A-027D-A56D34075E5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94307" y="3080012"/>
            <a:ext cx="2574600" cy="702163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81AB1D11-FA1D-B61E-1662-2974C0D1100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94307" y="3861732"/>
            <a:ext cx="2477496" cy="682424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41AE2653-DBB6-3E04-D086-C43D8B02521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51457" y="4679879"/>
            <a:ext cx="2357143" cy="742857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194436D7-313A-2EA1-603F-9DCDE28F86D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894307" y="5558459"/>
            <a:ext cx="2649243" cy="835667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8BE0FB0C-79C1-D9EB-77EE-A29B62D6CED0}"/>
              </a:ext>
            </a:extLst>
          </p:cNvPr>
          <p:cNvSpPr txBox="1"/>
          <p:nvPr/>
        </p:nvSpPr>
        <p:spPr>
          <a:xfrm>
            <a:off x="5528637" y="3964937"/>
            <a:ext cx="848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</a:t>
            </a:r>
            <a:r>
              <a:rPr lang="en-US" altLang="zh-CN" dirty="0" err="1"/>
              <a:t>myc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08F4573-1B70-5466-865A-3B668AE2DED0}"/>
              </a:ext>
            </a:extLst>
          </p:cNvPr>
          <p:cNvSpPr txBox="1"/>
          <p:nvPr/>
        </p:nvSpPr>
        <p:spPr>
          <a:xfrm>
            <a:off x="5429251" y="355011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TDB1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74AAB42-C658-8F69-0928-4CEEE723DA6B}"/>
              </a:ext>
            </a:extLst>
          </p:cNvPr>
          <p:cNvSpPr txBox="1"/>
          <p:nvPr/>
        </p:nvSpPr>
        <p:spPr>
          <a:xfrm>
            <a:off x="5468907" y="903398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IP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5684DF7-62F2-2486-63CF-D35FB4A1DF1D}"/>
              </a:ext>
            </a:extLst>
          </p:cNvPr>
          <p:cNvSpPr txBox="1"/>
          <p:nvPr/>
        </p:nvSpPr>
        <p:spPr>
          <a:xfrm>
            <a:off x="5429251" y="1488760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RE1α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A63513D-69F4-C87E-5638-544356B143CE}"/>
              </a:ext>
            </a:extLst>
          </p:cNvPr>
          <p:cNvSpPr txBox="1"/>
          <p:nvPr/>
        </p:nvSpPr>
        <p:spPr>
          <a:xfrm>
            <a:off x="5349483" y="4767884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K6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4401600-E72B-6574-2273-BAD1C16C22B4}"/>
              </a:ext>
            </a:extLst>
          </p:cNvPr>
          <p:cNvSpPr txBox="1"/>
          <p:nvPr/>
        </p:nvSpPr>
        <p:spPr>
          <a:xfrm>
            <a:off x="5468907" y="3181062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F6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D3DF2769-3E1F-4EE5-3500-446EA2B333B9}"/>
              </a:ext>
            </a:extLst>
          </p:cNvPr>
          <p:cNvSpPr txBox="1"/>
          <p:nvPr/>
        </p:nvSpPr>
        <p:spPr>
          <a:xfrm>
            <a:off x="5528637" y="2304579"/>
            <a:ext cx="936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ERK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606C786-B5F4-ECBB-2724-C068B799BB7B}"/>
              </a:ext>
            </a:extLst>
          </p:cNvPr>
          <p:cNvSpPr txBox="1"/>
          <p:nvPr/>
        </p:nvSpPr>
        <p:spPr>
          <a:xfrm>
            <a:off x="5497921" y="5643346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033351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C0B90A3-8821-82FA-E5EB-B62768FEDF00}"/>
              </a:ext>
            </a:extLst>
          </p:cNvPr>
          <p:cNvSpPr txBox="1"/>
          <p:nvPr/>
        </p:nvSpPr>
        <p:spPr>
          <a:xfrm>
            <a:off x="157110" y="164468"/>
            <a:ext cx="14888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ure6B</a:t>
            </a:r>
            <a:endParaRPr lang="zh-CN" altLang="en-US" sz="2400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F0B9432-5B4C-D5C5-6CAC-862026A797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30073" y="1126593"/>
            <a:ext cx="1372296" cy="924494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85CAA8C5-11F9-2F35-BC5C-E0C088A33EB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52802" y="2051087"/>
            <a:ext cx="1326840" cy="116353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E36F76F8-E1CD-20CD-D899-A57823393FA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65926" y="3178015"/>
            <a:ext cx="1560688" cy="124459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B9FEE3A3-BDBC-69E3-B42B-1E5686152AD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87885" y="4211196"/>
            <a:ext cx="1256673" cy="1012841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6E11D9B6-23D5-38CF-9B75-2329C4B17C8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594235" y="5224037"/>
            <a:ext cx="1312199" cy="1111353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84F335EA-0DF3-09CB-24CF-689A7139D7C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124950" y="2990263"/>
            <a:ext cx="1209492" cy="877474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1FCC2D6C-5F93-AAB2-9455-489E82D5542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077770" y="4235567"/>
            <a:ext cx="1426772" cy="1085862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FA8E0651-32D9-8C5A-9E84-07E05FD01A6C}"/>
              </a:ext>
            </a:extLst>
          </p:cNvPr>
          <p:cNvSpPr txBox="1"/>
          <p:nvPr/>
        </p:nvSpPr>
        <p:spPr>
          <a:xfrm>
            <a:off x="7966517" y="1361046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TDB1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FFF75C1-D8D9-FA3D-DA44-1D8242555D91}"/>
              </a:ext>
            </a:extLst>
          </p:cNvPr>
          <p:cNvSpPr txBox="1"/>
          <p:nvPr/>
        </p:nvSpPr>
        <p:spPr>
          <a:xfrm>
            <a:off x="10504542" y="4638009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B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68EC06F-7A57-67B5-6272-E5F8ACA32E3B}"/>
              </a:ext>
            </a:extLst>
          </p:cNvPr>
          <p:cNvSpPr txBox="1"/>
          <p:nvPr/>
        </p:nvSpPr>
        <p:spPr>
          <a:xfrm>
            <a:off x="8026614" y="2277646"/>
            <a:ext cx="596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A9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3351458-39A3-C81B-D63E-6DABFAE79658}"/>
              </a:ext>
            </a:extLst>
          </p:cNvPr>
          <p:cNvSpPr txBox="1"/>
          <p:nvPr/>
        </p:nvSpPr>
        <p:spPr>
          <a:xfrm>
            <a:off x="7879642" y="350158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K2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BDFEACB-4D59-DC5E-4F61-A6ACE5EDD70E}"/>
              </a:ext>
            </a:extLst>
          </p:cNvPr>
          <p:cNvSpPr txBox="1"/>
          <p:nvPr/>
        </p:nvSpPr>
        <p:spPr>
          <a:xfrm>
            <a:off x="7895399" y="4453993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DHA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9D945B9-18D1-0A3D-B115-8B87675C446D}"/>
              </a:ext>
            </a:extLst>
          </p:cNvPr>
          <p:cNvSpPr txBox="1"/>
          <p:nvPr/>
        </p:nvSpPr>
        <p:spPr>
          <a:xfrm>
            <a:off x="7926337" y="5595047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KM2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58332D5-FCD8-CD49-E852-A7A002B4A8BE}"/>
              </a:ext>
            </a:extLst>
          </p:cNvPr>
          <p:cNvSpPr txBox="1"/>
          <p:nvPr/>
        </p:nvSpPr>
        <p:spPr>
          <a:xfrm>
            <a:off x="10416229" y="3244334"/>
            <a:ext cx="716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GK1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F9D4941-2E85-B45D-EF67-B6DA1243CF46}"/>
              </a:ext>
            </a:extLst>
          </p:cNvPr>
          <p:cNvSpPr txBox="1"/>
          <p:nvPr/>
        </p:nvSpPr>
        <p:spPr>
          <a:xfrm>
            <a:off x="2629701" y="285965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GS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E940F6DF-AB4A-5877-579E-73B4A3999269}"/>
              </a:ext>
            </a:extLst>
          </p:cNvPr>
          <p:cNvSpPr txBox="1"/>
          <p:nvPr/>
        </p:nvSpPr>
        <p:spPr>
          <a:xfrm>
            <a:off x="8387360" y="404658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GC</a:t>
            </a:r>
            <a:endParaRPr lang="zh-CN" altLang="en-US" dirty="0"/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6EDD87AF-66B4-E7BC-5129-0C9611627B5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52169" y="998681"/>
            <a:ext cx="1587501" cy="724729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35D4E4D8-47DA-DB4D-1ED6-8EBABB6400F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83540" y="1904121"/>
            <a:ext cx="1796312" cy="1086142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41C282D3-A309-26D9-54FA-867BCBAF3A6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65847" y="3098793"/>
            <a:ext cx="1865408" cy="701521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E08F3A43-60FD-CA8C-AEED-71B3DB6C833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83540" y="5213635"/>
            <a:ext cx="1523392" cy="1032521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E562F698-9647-2138-DCDE-C8671FD05A8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78678" y="3908844"/>
            <a:ext cx="1628254" cy="1177886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5543F7A1-59EA-6135-F04E-497F9AFC1F6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407506" y="3042486"/>
            <a:ext cx="1560688" cy="1142359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5000DE7C-717F-A182-CFE8-5584CE94D60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403004" y="4271690"/>
            <a:ext cx="1523392" cy="974422"/>
          </a:xfrm>
          <a:prstGeom prst="rect">
            <a:avLst/>
          </a:prstGeom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A5C28D91-D12A-15CB-4C4D-7BF39367713E}"/>
              </a:ext>
            </a:extLst>
          </p:cNvPr>
          <p:cNvSpPr txBox="1"/>
          <p:nvPr/>
        </p:nvSpPr>
        <p:spPr>
          <a:xfrm>
            <a:off x="2429452" y="1361046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TDB1</a:t>
            </a:r>
            <a:endParaRPr lang="zh-CN" altLang="en-US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08FC9EBE-E386-3EFF-1E84-3CE16402E8F7}"/>
              </a:ext>
            </a:extLst>
          </p:cNvPr>
          <p:cNvSpPr txBox="1"/>
          <p:nvPr/>
        </p:nvSpPr>
        <p:spPr>
          <a:xfrm>
            <a:off x="4850887" y="466098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B</a:t>
            </a:r>
            <a:endParaRPr lang="zh-CN" altLang="en-US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405064D4-E766-5DBE-748D-1D8D64C4E875}"/>
              </a:ext>
            </a:extLst>
          </p:cNvPr>
          <p:cNvSpPr txBox="1"/>
          <p:nvPr/>
        </p:nvSpPr>
        <p:spPr>
          <a:xfrm>
            <a:off x="2489549" y="2277646"/>
            <a:ext cx="596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A9</a:t>
            </a:r>
            <a:endParaRPr lang="zh-CN" altLang="en-US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C7C8C105-7783-A89A-02A7-77B0CDAD718A}"/>
              </a:ext>
            </a:extLst>
          </p:cNvPr>
          <p:cNvSpPr txBox="1"/>
          <p:nvPr/>
        </p:nvSpPr>
        <p:spPr>
          <a:xfrm>
            <a:off x="2369608" y="3316919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K2</a:t>
            </a:r>
            <a:endParaRPr lang="zh-CN" altLang="en-US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56BFF079-8593-F905-30D1-C038F0F3E573}"/>
              </a:ext>
            </a:extLst>
          </p:cNvPr>
          <p:cNvSpPr txBox="1"/>
          <p:nvPr/>
        </p:nvSpPr>
        <p:spPr>
          <a:xfrm>
            <a:off x="2358334" y="4453993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DHA</a:t>
            </a:r>
            <a:endParaRPr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20B8A4ED-2A7E-D7C6-CE7D-6D1B6DC8E9C8}"/>
              </a:ext>
            </a:extLst>
          </p:cNvPr>
          <p:cNvSpPr txBox="1"/>
          <p:nvPr/>
        </p:nvSpPr>
        <p:spPr>
          <a:xfrm>
            <a:off x="2389272" y="5595047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KM2</a:t>
            </a:r>
            <a:endParaRPr lang="zh-CN" altLang="en-US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CC401880-1F34-D169-F12E-050646DFE637}"/>
              </a:ext>
            </a:extLst>
          </p:cNvPr>
          <p:cNvSpPr txBox="1"/>
          <p:nvPr/>
        </p:nvSpPr>
        <p:spPr>
          <a:xfrm>
            <a:off x="4965702" y="3316919"/>
            <a:ext cx="716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GK1</a:t>
            </a:r>
            <a:endParaRPr lang="zh-CN" altLang="en-US" dirty="0"/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0B0A0D04-9922-C7F6-1694-9286433EA589}"/>
              </a:ext>
            </a:extLst>
          </p:cNvPr>
          <p:cNvCxnSpPr/>
          <p:nvPr/>
        </p:nvCxnSpPr>
        <p:spPr>
          <a:xfrm>
            <a:off x="5759450" y="164468"/>
            <a:ext cx="0" cy="6318882"/>
          </a:xfrm>
          <a:prstGeom prst="line">
            <a:avLst/>
          </a:prstGeom>
          <a:ln w="22225"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893625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4F1138B-1C04-87FA-D9FB-E7FAFF9B0A3C}"/>
              </a:ext>
            </a:extLst>
          </p:cNvPr>
          <p:cNvSpPr txBox="1"/>
          <p:nvPr/>
        </p:nvSpPr>
        <p:spPr>
          <a:xfrm>
            <a:off x="157110" y="164468"/>
            <a:ext cx="14888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ure6C</a:t>
            </a:r>
            <a:endParaRPr lang="zh-CN" altLang="en-US" sz="2400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4B11CF22-4AAD-E92F-B5E6-D454BDBD33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2928" y="4775200"/>
            <a:ext cx="3111721" cy="84865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4453958B-1E8A-946F-8B40-3C86F3FDE3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3565" y="2747648"/>
            <a:ext cx="3111721" cy="540007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F08AE814-683E-304C-3BA7-AC498CBF5F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0315" y="3909142"/>
            <a:ext cx="3158223" cy="540007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E05DBBF8-9EC6-38D8-CC53-7AC54BEE66C5}"/>
              </a:ext>
            </a:extLst>
          </p:cNvPr>
          <p:cNvSpPr txBox="1"/>
          <p:nvPr/>
        </p:nvSpPr>
        <p:spPr>
          <a:xfrm>
            <a:off x="4776732" y="3994479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IF1α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7CC3E71-9AAA-B745-63E3-4004A65F8B17}"/>
              </a:ext>
            </a:extLst>
          </p:cNvPr>
          <p:cNvSpPr txBox="1"/>
          <p:nvPr/>
        </p:nvSpPr>
        <p:spPr>
          <a:xfrm>
            <a:off x="4894366" y="5152548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B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6875D96-336E-B4C0-8695-D3026A560824}"/>
              </a:ext>
            </a:extLst>
          </p:cNvPr>
          <p:cNvSpPr txBox="1"/>
          <p:nvPr/>
        </p:nvSpPr>
        <p:spPr>
          <a:xfrm>
            <a:off x="4776732" y="2747648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TDB1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ED6FE58-B155-273B-C108-ECBBAAB5085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63264" y="4842026"/>
            <a:ext cx="2712778" cy="823188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A086284F-EEA3-255E-2E41-1431B9F8C1D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81801" y="3636288"/>
            <a:ext cx="2994752" cy="812861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6701C76F-5D86-AA0D-A682-48F201DC0B7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763265" y="2630522"/>
            <a:ext cx="3224964" cy="612889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8251FC54-F5C0-5CC6-2EDE-6680CED37517}"/>
              </a:ext>
            </a:extLst>
          </p:cNvPr>
          <p:cNvSpPr txBox="1"/>
          <p:nvPr/>
        </p:nvSpPr>
        <p:spPr>
          <a:xfrm>
            <a:off x="10186158" y="3994479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IF1α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7D8BF19-48F0-CE1A-1F31-D7D43EC40DBF}"/>
              </a:ext>
            </a:extLst>
          </p:cNvPr>
          <p:cNvSpPr txBox="1"/>
          <p:nvPr/>
        </p:nvSpPr>
        <p:spPr>
          <a:xfrm>
            <a:off x="10303792" y="5152548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B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129407C-6FC5-0F34-F9AF-CC7525C3DD2A}"/>
              </a:ext>
            </a:extLst>
          </p:cNvPr>
          <p:cNvSpPr txBox="1"/>
          <p:nvPr/>
        </p:nvSpPr>
        <p:spPr>
          <a:xfrm>
            <a:off x="10186158" y="2747648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TDB1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92D6C45-7205-32B7-F319-904F7F1CF345}"/>
              </a:ext>
            </a:extLst>
          </p:cNvPr>
          <p:cNvSpPr txBox="1"/>
          <p:nvPr/>
        </p:nvSpPr>
        <p:spPr>
          <a:xfrm>
            <a:off x="2740406" y="1891615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GS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386646B-4FDF-E2B4-206D-3D2CCBD7C490}"/>
              </a:ext>
            </a:extLst>
          </p:cNvPr>
          <p:cNvSpPr txBox="1"/>
          <p:nvPr/>
        </p:nvSpPr>
        <p:spPr>
          <a:xfrm>
            <a:off x="8197342" y="1993731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GC</a:t>
            </a:r>
            <a:endParaRPr lang="zh-CN" altLang="en-US" dirty="0"/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BDC4B3DE-57DF-C3BA-11BE-BEB0158274AE}"/>
              </a:ext>
            </a:extLst>
          </p:cNvPr>
          <p:cNvCxnSpPr/>
          <p:nvPr/>
        </p:nvCxnSpPr>
        <p:spPr>
          <a:xfrm>
            <a:off x="6027464" y="164468"/>
            <a:ext cx="0" cy="6318882"/>
          </a:xfrm>
          <a:prstGeom prst="line">
            <a:avLst/>
          </a:prstGeom>
          <a:ln w="22225"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53259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5</TotalTime>
  <Words>101</Words>
  <Application>Microsoft Office PowerPoint</Application>
  <PresentationFormat>宽屏</PresentationFormat>
  <Paragraphs>97</Paragraphs>
  <Slides>8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unyang Tan</dc:creator>
  <cp:lastModifiedBy>Junyang Tan</cp:lastModifiedBy>
  <cp:revision>23</cp:revision>
  <dcterms:created xsi:type="dcterms:W3CDTF">2025-11-01T02:00:20Z</dcterms:created>
  <dcterms:modified xsi:type="dcterms:W3CDTF">2025-11-03T09:27:19Z</dcterms:modified>
</cp:coreProperties>
</file>